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sldIdLst>
    <p:sldId id="312" r:id="rId2"/>
    <p:sldId id="315" r:id="rId3"/>
    <p:sldId id="313" r:id="rId4"/>
    <p:sldId id="307" r:id="rId5"/>
    <p:sldId id="314" r:id="rId6"/>
  </p:sldIdLst>
  <p:sldSz cx="12192000" cy="6858000"/>
  <p:notesSz cx="6858000" cy="9144000"/>
  <p:custDataLst>
    <p:tags r:id="rId7"/>
  </p:custDataLst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135"/>
    <p:restoredTop sz="96405"/>
  </p:normalViewPr>
  <p:slideViewPr>
    <p:cSldViewPr snapToGrid="0">
      <p:cViewPr varScale="1">
        <p:scale>
          <a:sx n="127" d="100"/>
          <a:sy n="127" d="100"/>
        </p:scale>
        <p:origin x="68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tags" Target="tags/tag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 hasCustomPrompt="1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/>
          <p:cNvSpPr>
            <a:spLocks noGrp="1"/>
          </p:cNvSpPr>
          <p:nvPr>
            <p:ph type="subTitle" idx="1" hasCustomPrompt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AF123-B12B-984C-9CDE-57FC4D089367}" type="datetimeFigureOut">
              <a:rPr lang="sv-SE" smtClean="0"/>
              <a:t>2025-11-24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EBEE5-A6FD-3C44-9DE5-D0A168F07592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AF123-B12B-984C-9CDE-57FC4D089367}" type="datetimeFigureOut">
              <a:rPr lang="sv-SE" smtClean="0"/>
              <a:t>2025-11-24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EBEE5-A6FD-3C44-9DE5-D0A168F07592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 hasCustomPrompt="1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 hasCustomPrompt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AF123-B12B-984C-9CDE-57FC4D089367}" type="datetimeFigureOut">
              <a:rPr lang="sv-SE" smtClean="0"/>
              <a:t>2025-11-24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EBEE5-A6FD-3C44-9DE5-D0A168F07592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AF123-B12B-984C-9CDE-57FC4D089367}" type="datetimeFigureOut">
              <a:rPr lang="sv-SE" smtClean="0"/>
              <a:t>2025-11-24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EBEE5-A6FD-3C44-9DE5-D0A168F07592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 hasCustomPrompt="1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 hasCustomPrompt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AF123-B12B-984C-9CDE-57FC4D089367}" type="datetimeFigureOut">
              <a:rPr lang="sv-SE" smtClean="0"/>
              <a:t>2025-11-24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EBEE5-A6FD-3C44-9DE5-D0A168F07592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 hasCustomPrompt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 hasCustomPrompt="1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AF123-B12B-984C-9CDE-57FC4D089367}" type="datetimeFigureOut">
              <a:rPr lang="sv-SE" smtClean="0"/>
              <a:t>2025-11-24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EBEE5-A6FD-3C44-9DE5-D0A168F07592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 hasCustomPrompt="1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 hasCustomPrompt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 hasCustomPrompt="1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 hasCustomPrompt="1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 hasCustomPrompt="1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AF123-B12B-984C-9CDE-57FC4D089367}" type="datetimeFigureOut">
              <a:rPr lang="sv-SE" smtClean="0"/>
              <a:t>2025-11-24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EBEE5-A6FD-3C44-9DE5-D0A168F07592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AF123-B12B-984C-9CDE-57FC4D089367}" type="datetimeFigureOut">
              <a:rPr lang="sv-SE" smtClean="0"/>
              <a:t>2025-11-24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EBEE5-A6FD-3C44-9DE5-D0A168F07592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AF123-B12B-984C-9CDE-57FC4D089367}" type="datetimeFigureOut">
              <a:rPr lang="sv-SE" smtClean="0"/>
              <a:t>2025-11-24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EBEE5-A6FD-3C44-9DE5-D0A168F07592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 hasCustomPrompt="1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idx="1" hasCustomPrompt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AF123-B12B-984C-9CDE-57FC4D089367}" type="datetimeFigureOut">
              <a:rPr lang="sv-SE" smtClean="0"/>
              <a:t>2025-11-24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EBEE5-A6FD-3C44-9DE5-D0A168F07592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 hasCustomPrompt="1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AF123-B12B-984C-9CDE-57FC4D089367}" type="datetimeFigureOut">
              <a:rPr lang="sv-SE" smtClean="0"/>
              <a:t>2025-11-24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EBEE5-A6FD-3C44-9DE5-D0A168F07592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CAF123-B12B-984C-9CDE-57FC4D089367}" type="datetimeFigureOut">
              <a:rPr lang="sv-SE" smtClean="0"/>
              <a:t>2025-11-24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9EBEE5-A6FD-3C44-9DE5-D0A168F07592}" type="slidenum">
              <a:rPr lang="sv-SE" smtClean="0"/>
              <a:t>‹#›</a:t>
            </a:fld>
            <a:endParaRPr lang="sv-S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package" Target="../embeddings/Microsoft_Excel-kalkylblad.xlsx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164310A5-09BD-43FE-CE2A-B97CC95868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89721" y="4440168"/>
            <a:ext cx="1622612" cy="1988110"/>
          </a:xfrm>
        </p:spPr>
        <p:txBody>
          <a:bodyPr>
            <a:normAutofit/>
          </a:bodyPr>
          <a:lstStyle/>
          <a:p>
            <a:r>
              <a:rPr lang="sv-SE" sz="1600" b="1" dirty="0"/>
              <a:t>Suppl. Table 1</a:t>
            </a:r>
            <a:br>
              <a:rPr lang="sv-SE" dirty="0"/>
            </a:br>
            <a:r>
              <a:rPr lang="sv-SE" sz="1200" dirty="0"/>
              <a:t>List </a:t>
            </a:r>
            <a:r>
              <a:rPr lang="sv-SE" sz="1200" dirty="0" err="1"/>
              <a:t>of</a:t>
            </a:r>
            <a:r>
              <a:rPr lang="sv-SE" sz="1200" dirty="0"/>
              <a:t> DE genes (</a:t>
            </a:r>
            <a:r>
              <a:rPr lang="sv-SE" sz="1200" dirty="0" err="1"/>
              <a:t>see</a:t>
            </a:r>
            <a:r>
              <a:rPr lang="sv-SE" sz="1200" dirty="0"/>
              <a:t> </a:t>
            </a:r>
            <a:r>
              <a:rPr lang="sv-SE" sz="1200" dirty="0" err="1"/>
              <a:t>separate</a:t>
            </a:r>
            <a:r>
              <a:rPr lang="sv-SE" sz="1200" dirty="0"/>
              <a:t> </a:t>
            </a:r>
            <a:r>
              <a:rPr lang="sv-SE" sz="1200" dirty="0" err="1"/>
              <a:t>File</a:t>
            </a:r>
            <a:r>
              <a:rPr lang="sv-SE" sz="1200" dirty="0"/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29916476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 3">
            <a:extLst>
              <a:ext uri="{FF2B5EF4-FFF2-40B4-BE49-F238E27FC236}">
                <a16:creationId xmlns:a16="http://schemas.microsoft.com/office/drawing/2014/main" id="{E3E6C15E-6C04-8587-49FA-2E624BF8DE7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65940466"/>
              </p:ext>
            </p:extLst>
          </p:nvPr>
        </p:nvGraphicFramePr>
        <p:xfrm>
          <a:off x="258418" y="47107"/>
          <a:ext cx="8239538" cy="568901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63346">
                  <a:extLst>
                    <a:ext uri="{9D8B030D-6E8A-4147-A177-3AD203B41FA5}">
                      <a16:colId xmlns:a16="http://schemas.microsoft.com/office/drawing/2014/main" val="1558661204"/>
                    </a:ext>
                  </a:extLst>
                </a:gridCol>
                <a:gridCol w="1788575">
                  <a:extLst>
                    <a:ext uri="{9D8B030D-6E8A-4147-A177-3AD203B41FA5}">
                      <a16:colId xmlns:a16="http://schemas.microsoft.com/office/drawing/2014/main" val="2713776355"/>
                    </a:ext>
                  </a:extLst>
                </a:gridCol>
                <a:gridCol w="1729409">
                  <a:extLst>
                    <a:ext uri="{9D8B030D-6E8A-4147-A177-3AD203B41FA5}">
                      <a16:colId xmlns:a16="http://schemas.microsoft.com/office/drawing/2014/main" val="2372926545"/>
                    </a:ext>
                  </a:extLst>
                </a:gridCol>
                <a:gridCol w="1798983">
                  <a:extLst>
                    <a:ext uri="{9D8B030D-6E8A-4147-A177-3AD203B41FA5}">
                      <a16:colId xmlns:a16="http://schemas.microsoft.com/office/drawing/2014/main" val="612676395"/>
                    </a:ext>
                  </a:extLst>
                </a:gridCol>
                <a:gridCol w="1759225">
                  <a:extLst>
                    <a:ext uri="{9D8B030D-6E8A-4147-A177-3AD203B41FA5}">
                      <a16:colId xmlns:a16="http://schemas.microsoft.com/office/drawing/2014/main" val="2911940352"/>
                    </a:ext>
                  </a:extLst>
                </a:gridCol>
              </a:tblGrid>
              <a:tr h="556476"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 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v-SE" sz="900" dirty="0">
                          <a:effectLst/>
                        </a:rPr>
                        <a:t>RNA-</a:t>
                      </a:r>
                      <a:r>
                        <a:rPr lang="sv-SE" sz="900" dirty="0" err="1">
                          <a:effectLst/>
                        </a:rPr>
                        <a:t>seq</a:t>
                      </a:r>
                      <a:r>
                        <a:rPr lang="sv-SE" sz="900" dirty="0">
                          <a:effectLst/>
                        </a:rPr>
                        <a:t> (FPKM)</a:t>
                      </a:r>
                      <a:endParaRPr lang="sv-SE" sz="900" dirty="0">
                        <a:effectLst/>
                        <a:latin typeface="Times New Roman" panose="02020603050405020304" pitchFamily="18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sv-SE" sz="900" dirty="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v-SE" sz="900" dirty="0">
                          <a:effectLst/>
                        </a:rPr>
                        <a:t>RNA-</a:t>
                      </a:r>
                      <a:r>
                        <a:rPr lang="sv-SE" sz="900" dirty="0" err="1">
                          <a:effectLst/>
                        </a:rPr>
                        <a:t>seq</a:t>
                      </a:r>
                      <a:r>
                        <a:rPr lang="sv-SE" sz="900" dirty="0">
                          <a:effectLst/>
                        </a:rPr>
                        <a:t> (FPKM)</a:t>
                      </a:r>
                      <a:endParaRPr lang="sv-SE" sz="900" dirty="0">
                        <a:effectLst/>
                        <a:latin typeface="Times New Roman" panose="02020603050405020304" pitchFamily="18" charset="0"/>
                      </a:endParaRPr>
                    </a:p>
                    <a:p>
                      <a:endParaRPr lang="sv-SE" sz="900" dirty="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sv-SE" sz="900" dirty="0">
                        <a:effectLst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sv-SE" sz="900" dirty="0">
                        <a:effectLst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v-SE" sz="900" dirty="0" err="1">
                          <a:effectLst/>
                        </a:rPr>
                        <a:t>qPCR</a:t>
                      </a:r>
                      <a:r>
                        <a:rPr lang="sv-SE" sz="900" dirty="0">
                          <a:effectLst/>
                        </a:rPr>
                        <a:t> (Relative mRNA expression)</a:t>
                      </a:r>
                      <a:endParaRPr lang="sv-SE" sz="900" dirty="0">
                        <a:effectLst/>
                        <a:latin typeface="Times New Roman" panose="02020603050405020304" pitchFamily="18" charset="0"/>
                      </a:endParaRPr>
                    </a:p>
                    <a:p>
                      <a:endParaRPr lang="sv-SE" sz="900" dirty="0"/>
                    </a:p>
                  </a:txBody>
                  <a:tcPr marL="24411" marR="24411" marT="12206" marB="12206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sv-SE" sz="900" dirty="0">
                        <a:effectLst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sv-SE" sz="900" dirty="0">
                        <a:effectLst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v-SE" sz="900" dirty="0" err="1">
                          <a:effectLst/>
                        </a:rPr>
                        <a:t>qPCR</a:t>
                      </a:r>
                      <a:r>
                        <a:rPr lang="sv-SE" sz="900" dirty="0">
                          <a:effectLst/>
                        </a:rPr>
                        <a:t> (Relative mRNA expression)</a:t>
                      </a:r>
                      <a:endParaRPr lang="sv-SE" sz="900" dirty="0">
                        <a:effectLst/>
                        <a:latin typeface="Times New Roman" panose="02020603050405020304" pitchFamily="18" charset="0"/>
                      </a:endParaRPr>
                    </a:p>
                    <a:p>
                      <a:endParaRPr lang="sv-SE" sz="900" dirty="0"/>
                    </a:p>
                  </a:txBody>
                  <a:tcPr marL="24411" marR="24411" marT="12206" marB="12206"/>
                </a:tc>
                <a:extLst>
                  <a:ext uri="{0D108BD9-81ED-4DB2-BD59-A6C34878D82A}">
                    <a16:rowId xmlns:a16="http://schemas.microsoft.com/office/drawing/2014/main" val="1494471019"/>
                  </a:ext>
                </a:extLst>
              </a:tr>
              <a:tr h="190689">
                <a:tc>
                  <a:txBody>
                    <a:bodyPr/>
                    <a:lstStyle/>
                    <a:p>
                      <a:r>
                        <a:rPr lang="sv-SE" sz="900" u="sng">
                          <a:effectLst/>
                        </a:rPr>
                        <a:t>Gene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 u="sng">
                          <a:effectLst/>
                        </a:rPr>
                        <a:t>WT1-3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 u="sng" dirty="0">
                          <a:effectLst/>
                        </a:rPr>
                        <a:t>Mut1-5</a:t>
                      </a:r>
                      <a:endParaRPr lang="sv-SE" sz="900" dirty="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 u="sng">
                          <a:effectLst/>
                        </a:rPr>
                        <a:t>WT1-3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 u="sng">
                          <a:effectLst/>
                        </a:rPr>
                        <a:t>Mut1-3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extLst>
                  <a:ext uri="{0D108BD9-81ED-4DB2-BD59-A6C34878D82A}">
                    <a16:rowId xmlns:a16="http://schemas.microsoft.com/office/drawing/2014/main" val="2333434876"/>
                  </a:ext>
                </a:extLst>
              </a:tr>
              <a:tr h="378867"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INS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4708.34± 204.65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4126.39± 162.91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1.00± 0.14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0.49± 0.05 *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extLst>
                  <a:ext uri="{0D108BD9-81ED-4DB2-BD59-A6C34878D82A}">
                    <a16:rowId xmlns:a16="http://schemas.microsoft.com/office/drawing/2014/main" val="3361372958"/>
                  </a:ext>
                </a:extLst>
              </a:tr>
              <a:tr h="378867"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PAX4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0.90± 0.13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 dirty="0">
                          <a:effectLst/>
                        </a:rPr>
                        <a:t>0.58± 0.15</a:t>
                      </a:r>
                      <a:endParaRPr lang="sv-SE" sz="900" dirty="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1.00± 0.07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 dirty="0">
                          <a:effectLst/>
                        </a:rPr>
                        <a:t>0.62± 0.04 *</a:t>
                      </a:r>
                      <a:endParaRPr lang="sv-SE" sz="900" dirty="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extLst>
                  <a:ext uri="{0D108BD9-81ED-4DB2-BD59-A6C34878D82A}">
                    <a16:rowId xmlns:a16="http://schemas.microsoft.com/office/drawing/2014/main" val="3045986306"/>
                  </a:ext>
                </a:extLst>
              </a:tr>
              <a:tr h="378867"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GCG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0.31± 0.04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1.07± 0.16 ***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1.00± 0.13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2.76± 0.18 ***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extLst>
                  <a:ext uri="{0D108BD9-81ED-4DB2-BD59-A6C34878D82A}">
                    <a16:rowId xmlns:a16="http://schemas.microsoft.com/office/drawing/2014/main" val="234106476"/>
                  </a:ext>
                </a:extLst>
              </a:tr>
              <a:tr h="378867"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ARX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0.57± 0.05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7.79± 1.30 ***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1.00± 0.26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4.11± 0.68 ***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extLst>
                  <a:ext uri="{0D108BD9-81ED-4DB2-BD59-A6C34878D82A}">
                    <a16:rowId xmlns:a16="http://schemas.microsoft.com/office/drawing/2014/main" val="2711969371"/>
                  </a:ext>
                </a:extLst>
              </a:tr>
              <a:tr h="378867"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IAPP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42.05± 10.60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183.94± 46.80 **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1.00± 0.11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3.59± 0.22 ***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extLst>
                  <a:ext uri="{0D108BD9-81ED-4DB2-BD59-A6C34878D82A}">
                    <a16:rowId xmlns:a16="http://schemas.microsoft.com/office/drawing/2014/main" val="166721501"/>
                  </a:ext>
                </a:extLst>
              </a:tr>
              <a:tr h="378867"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MYC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0.08± 0.02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0.36± 0.04 ***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1.00± 0.14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3.61± 0.24 ***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extLst>
                  <a:ext uri="{0D108BD9-81ED-4DB2-BD59-A6C34878D82A}">
                    <a16:rowId xmlns:a16="http://schemas.microsoft.com/office/drawing/2014/main" val="1432111043"/>
                  </a:ext>
                </a:extLst>
              </a:tr>
              <a:tr h="378867"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FOXB1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0.88± 0.06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0.06± 0.01 ***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1.00± 0.13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0.04± 0.02 ***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extLst>
                  <a:ext uri="{0D108BD9-81ED-4DB2-BD59-A6C34878D82A}">
                    <a16:rowId xmlns:a16="http://schemas.microsoft.com/office/drawing/2014/main" val="1614893"/>
                  </a:ext>
                </a:extLst>
              </a:tr>
              <a:tr h="378867"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GLP1R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0.53± 0.04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0.13± 0.02 ***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1.00± 0.09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0.32± 0.04 *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extLst>
                  <a:ext uri="{0D108BD9-81ED-4DB2-BD59-A6C34878D82A}">
                    <a16:rowId xmlns:a16="http://schemas.microsoft.com/office/drawing/2014/main" val="2518579657"/>
                  </a:ext>
                </a:extLst>
              </a:tr>
              <a:tr h="378867"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SERPINA1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25.12± 3.16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2.48± 1.01 ***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1.00± 0.09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 dirty="0">
                          <a:effectLst/>
                        </a:rPr>
                        <a:t>0.10± 0.03 **</a:t>
                      </a:r>
                      <a:endParaRPr lang="sv-SE" sz="900" dirty="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extLst>
                  <a:ext uri="{0D108BD9-81ED-4DB2-BD59-A6C34878D82A}">
                    <a16:rowId xmlns:a16="http://schemas.microsoft.com/office/drawing/2014/main" val="693970397"/>
                  </a:ext>
                </a:extLst>
              </a:tr>
              <a:tr h="378867"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HK1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55.31± 5.54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143.84± 11.74 ***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1.00± 0.24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1.86± 0.30 *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extLst>
                  <a:ext uri="{0D108BD9-81ED-4DB2-BD59-A6C34878D82A}">
                    <a16:rowId xmlns:a16="http://schemas.microsoft.com/office/drawing/2014/main" val="4073278682"/>
                  </a:ext>
                </a:extLst>
              </a:tr>
              <a:tr h="378867"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PDGFRB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16.36± 1.93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80.12± 6.76 ***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1.00± 0.05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3.45± 0.26 ***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extLst>
                  <a:ext uri="{0D108BD9-81ED-4DB2-BD59-A6C34878D82A}">
                    <a16:rowId xmlns:a16="http://schemas.microsoft.com/office/drawing/2014/main" val="4173475873"/>
                  </a:ext>
                </a:extLst>
              </a:tr>
              <a:tr h="378867"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NEUROG3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1391.79± 56.60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3.55± 1.49 ***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1.00± 0.11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0.02± 0.01 ***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extLst>
                  <a:ext uri="{0D108BD9-81ED-4DB2-BD59-A6C34878D82A}">
                    <a16:rowId xmlns:a16="http://schemas.microsoft.com/office/drawing/2014/main" val="3810335052"/>
                  </a:ext>
                </a:extLst>
              </a:tr>
              <a:tr h="378867"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LDHA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6845.98± 387.81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11763.10± 294.64 ***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>
                          <a:effectLst/>
                        </a:rPr>
                        <a:t>1.00± 0.13</a:t>
                      </a:r>
                      <a:endParaRPr lang="sv-SE" sz="9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tc>
                  <a:txBody>
                    <a:bodyPr/>
                    <a:lstStyle/>
                    <a:p>
                      <a:r>
                        <a:rPr lang="sv-SE" sz="900" dirty="0">
                          <a:effectLst/>
                        </a:rPr>
                        <a:t>1.38± 0.07 *</a:t>
                      </a:r>
                      <a:endParaRPr lang="sv-SE" sz="900" dirty="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034" marR="2034" marT="2034" marB="0" anchor="b"/>
                </a:tc>
                <a:extLst>
                  <a:ext uri="{0D108BD9-81ED-4DB2-BD59-A6C34878D82A}">
                    <a16:rowId xmlns:a16="http://schemas.microsoft.com/office/drawing/2014/main" val="1528241973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E132319C-CAF5-178F-DF0C-C1919E60D1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8905" y="5841397"/>
            <a:ext cx="10903570" cy="9694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1400" b="0" i="0" u="sng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Suppl. Table  2</a:t>
            </a:r>
            <a:br>
              <a:rPr kumimoji="0" lang="sv-SE" altLang="sv-SE" sz="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</a:br>
            <a:endParaRPr kumimoji="0" lang="sv-SE" altLang="sv-SE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Differentially</a:t>
            </a: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expressed</a:t>
            </a: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 genes, </a:t>
            </a: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when</a:t>
            </a: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comparing</a:t>
            </a: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mutated</a:t>
            </a: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clones</a:t>
            </a: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 1-3 </a:t>
            </a: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with</a:t>
            </a: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wt</a:t>
            </a: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clones</a:t>
            </a: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 1-5, </a:t>
            </a: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verified</a:t>
            </a: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 by </a:t>
            </a: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qPCR</a:t>
            </a: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. ** and *** </a:t>
            </a: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denote</a:t>
            </a: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,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in RNA-</a:t>
            </a: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seq</a:t>
            </a: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 experiments, p&lt;0.01 and p&lt;0.001, </a:t>
            </a: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respectively</a:t>
            </a: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, </a:t>
            </a: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using</a:t>
            </a: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 the FDR test. *, ** and *** </a:t>
            </a: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denote</a:t>
            </a: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, in </a:t>
            </a: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qPCR</a:t>
            </a: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 experiments,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p&lt;0.05, p&lt;0.01 and p&lt;0.001, </a:t>
            </a: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respectively</a:t>
            </a: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when</a:t>
            </a: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using</a:t>
            </a: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Student’s</a:t>
            </a: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 T-test. All </a:t>
            </a: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clones</a:t>
            </a: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were</a:t>
            </a: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analyzed</a:t>
            </a:r>
            <a:r>
              <a:rPr kumimoji="0" lang="sv-SE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 in </a:t>
            </a:r>
            <a:r>
              <a:rPr kumimoji="0" lang="sv-SE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duplicates</a:t>
            </a:r>
            <a:r>
              <a:rPr kumimoji="0" lang="sv-SE" altLang="sv-SE" sz="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</a:rPr>
              <a:t>.</a:t>
            </a:r>
            <a:endParaRPr kumimoji="0" lang="sv-SE" altLang="sv-SE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15724057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31947120-1505-8C42-B8E9-BD29A3BDF4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32522" y="4781922"/>
            <a:ext cx="2083676" cy="2007704"/>
          </a:xfrm>
        </p:spPr>
        <p:txBody>
          <a:bodyPr>
            <a:normAutofit/>
          </a:bodyPr>
          <a:lstStyle/>
          <a:p>
            <a:r>
              <a:rPr lang="sv-SE" sz="1400" b="1" dirty="0"/>
              <a:t>Suppl. Table 3</a:t>
            </a:r>
            <a:br>
              <a:rPr lang="sv-SE" dirty="0"/>
            </a:br>
            <a:r>
              <a:rPr lang="sv-SE" sz="1200" u="sng" dirty="0" err="1"/>
              <a:t>Alternatively</a:t>
            </a:r>
            <a:r>
              <a:rPr lang="sv-SE" sz="1200" u="sng" dirty="0"/>
              <a:t> </a:t>
            </a:r>
            <a:r>
              <a:rPr lang="sv-SE" sz="1200" u="sng" dirty="0" err="1"/>
              <a:t>spliced</a:t>
            </a:r>
            <a:r>
              <a:rPr lang="sv-SE" sz="1200" u="sng" dirty="0"/>
              <a:t> genes </a:t>
            </a:r>
            <a:r>
              <a:rPr lang="sv-SE" sz="1200" u="sng" dirty="0" err="1"/>
              <a:t>when</a:t>
            </a:r>
            <a:r>
              <a:rPr lang="sv-SE" sz="1200" u="sng" dirty="0"/>
              <a:t> </a:t>
            </a:r>
            <a:r>
              <a:rPr lang="sv-SE" sz="1200" u="sng" dirty="0" err="1"/>
              <a:t>comparing</a:t>
            </a:r>
            <a:r>
              <a:rPr lang="sv-SE" sz="1200" u="sng" dirty="0"/>
              <a:t> </a:t>
            </a:r>
            <a:r>
              <a:rPr lang="sv-SE" sz="1200" u="sng" dirty="0" err="1"/>
              <a:t>wt</a:t>
            </a:r>
            <a:r>
              <a:rPr lang="sv-SE" sz="1200" u="sng" dirty="0"/>
              <a:t> 1-5 </a:t>
            </a:r>
            <a:r>
              <a:rPr lang="sv-SE" sz="1200" u="sng" dirty="0" err="1"/>
              <a:t>with</a:t>
            </a:r>
            <a:r>
              <a:rPr lang="sv-SE" sz="1200" u="sng" dirty="0"/>
              <a:t> </a:t>
            </a:r>
            <a:r>
              <a:rPr lang="sv-SE" sz="1200" u="sng" dirty="0" err="1"/>
              <a:t>mut</a:t>
            </a:r>
            <a:r>
              <a:rPr lang="sv-SE" sz="1200" u="sng" dirty="0"/>
              <a:t> 1-3 </a:t>
            </a:r>
            <a:r>
              <a:rPr lang="sv-SE" sz="1200" u="sng" dirty="0" err="1"/>
              <a:t>clones</a:t>
            </a:r>
            <a:r>
              <a:rPr lang="sv-SE" sz="1200" u="sng" dirty="0"/>
              <a:t>.</a:t>
            </a:r>
            <a:br>
              <a:rPr lang="sv-SE" sz="1200" dirty="0"/>
            </a:br>
            <a:r>
              <a:rPr lang="sv-SE" sz="1200" dirty="0"/>
              <a:t>RI=</a:t>
            </a:r>
            <a:r>
              <a:rPr lang="sv-SE" sz="1200" dirty="0" err="1"/>
              <a:t>retained</a:t>
            </a:r>
            <a:r>
              <a:rPr lang="sv-SE" sz="1200" dirty="0"/>
              <a:t> introns, MXE=</a:t>
            </a:r>
            <a:r>
              <a:rPr lang="sv-SE" sz="1200" dirty="0" err="1"/>
              <a:t>mutually</a:t>
            </a:r>
            <a:r>
              <a:rPr lang="sv-SE" sz="1200" dirty="0"/>
              <a:t> </a:t>
            </a:r>
            <a:r>
              <a:rPr lang="sv-SE" sz="1200" dirty="0" err="1"/>
              <a:t>exclusive</a:t>
            </a:r>
            <a:r>
              <a:rPr lang="sv-SE" sz="1200" dirty="0"/>
              <a:t> </a:t>
            </a:r>
            <a:r>
              <a:rPr lang="sv-SE" sz="1200" dirty="0" err="1"/>
              <a:t>exons</a:t>
            </a:r>
            <a:r>
              <a:rPr lang="sv-SE" sz="1200" dirty="0"/>
              <a:t>, A5SS=alternative 5’ </a:t>
            </a:r>
            <a:r>
              <a:rPr lang="sv-SE" sz="1200" dirty="0" err="1"/>
              <a:t>splice</a:t>
            </a:r>
            <a:r>
              <a:rPr lang="sv-SE" sz="1200" dirty="0"/>
              <a:t> site, A3SS=alternative 3’ </a:t>
            </a:r>
            <a:r>
              <a:rPr lang="sv-SE" sz="1200" dirty="0" err="1"/>
              <a:t>splice</a:t>
            </a:r>
            <a:r>
              <a:rPr lang="sv-SE" sz="1200" dirty="0"/>
              <a:t> site,</a:t>
            </a:r>
            <a:br>
              <a:rPr lang="sv-SE" sz="1200" dirty="0"/>
            </a:br>
            <a:r>
              <a:rPr lang="sv-SE" sz="1200" dirty="0"/>
              <a:t>SE=</a:t>
            </a:r>
            <a:r>
              <a:rPr lang="sv-SE" sz="1200" dirty="0" err="1"/>
              <a:t>exon</a:t>
            </a:r>
            <a:r>
              <a:rPr lang="sv-SE" sz="1200" dirty="0"/>
              <a:t> </a:t>
            </a:r>
            <a:r>
              <a:rPr lang="sv-SE" sz="1200" dirty="0" err="1"/>
              <a:t>skipping</a:t>
            </a:r>
            <a:endParaRPr lang="sv-SE" sz="1200" dirty="0"/>
          </a:p>
        </p:txBody>
      </p:sp>
      <p:graphicFrame>
        <p:nvGraphicFramePr>
          <p:cNvPr id="7" name="Objekt 6">
            <a:extLst>
              <a:ext uri="{FF2B5EF4-FFF2-40B4-BE49-F238E27FC236}">
                <a16:creationId xmlns:a16="http://schemas.microsoft.com/office/drawing/2014/main" id="{7FAD5855-046D-F67E-EC6D-B7592306907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83432118"/>
              </p:ext>
            </p:extLst>
          </p:nvPr>
        </p:nvGraphicFramePr>
        <p:xfrm>
          <a:off x="3613150" y="54680"/>
          <a:ext cx="6161471" cy="67250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Kalkylblad" r:id="rId2" imgW="18999200" imgH="20739100" progId="Excel.Sheet.12">
                  <p:embed/>
                </p:oleObj>
              </mc:Choice>
              <mc:Fallback>
                <p:oleObj name="Kalkylblad" r:id="rId2" imgW="18999200" imgH="207391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613150" y="54680"/>
                        <a:ext cx="6161471" cy="67250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1607498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C345C8DE-2B9D-BCA6-5C46-03879C27F7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901220"/>
            <a:ext cx="10515600" cy="1325563"/>
          </a:xfrm>
        </p:spPr>
        <p:txBody>
          <a:bodyPr/>
          <a:lstStyle/>
          <a:p>
            <a:r>
              <a:rPr lang="sv-SE" sz="1400" b="1" dirty="0"/>
              <a:t>Suppl. Table 4</a:t>
            </a:r>
            <a:br>
              <a:rPr lang="sv-SE" dirty="0"/>
            </a:br>
            <a:r>
              <a:rPr lang="sv-SE" sz="1400" dirty="0"/>
              <a:t>Primers </a:t>
            </a:r>
            <a:r>
              <a:rPr lang="sv-SE" sz="1400" dirty="0" err="1"/>
              <a:t>used</a:t>
            </a:r>
            <a:r>
              <a:rPr lang="sv-SE" sz="1400" dirty="0"/>
              <a:t> for </a:t>
            </a:r>
            <a:r>
              <a:rPr lang="sv-SE" sz="1400" dirty="0" err="1"/>
              <a:t>prime</a:t>
            </a:r>
            <a:r>
              <a:rPr lang="sv-SE" sz="1400" dirty="0"/>
              <a:t> </a:t>
            </a:r>
            <a:r>
              <a:rPr lang="sv-SE" sz="1400" dirty="0" err="1"/>
              <a:t>editing</a:t>
            </a:r>
            <a:endParaRPr lang="sv-SE" sz="1400" dirty="0"/>
          </a:p>
        </p:txBody>
      </p:sp>
      <p:graphicFrame>
        <p:nvGraphicFramePr>
          <p:cNvPr id="5" name="Tabell 4">
            <a:extLst>
              <a:ext uri="{FF2B5EF4-FFF2-40B4-BE49-F238E27FC236}">
                <a16:creationId xmlns:a16="http://schemas.microsoft.com/office/drawing/2014/main" id="{7542235E-7BDE-05DA-9E9A-34F40DC6A2A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6034138"/>
              </p:ext>
            </p:extLst>
          </p:nvPr>
        </p:nvGraphicFramePr>
        <p:xfrm>
          <a:off x="649357" y="479494"/>
          <a:ext cx="10515600" cy="95071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115335">
                  <a:extLst>
                    <a:ext uri="{9D8B030D-6E8A-4147-A177-3AD203B41FA5}">
                      <a16:colId xmlns:a16="http://schemas.microsoft.com/office/drawing/2014/main" val="1732224426"/>
                    </a:ext>
                  </a:extLst>
                </a:gridCol>
                <a:gridCol w="689901">
                  <a:extLst>
                    <a:ext uri="{9D8B030D-6E8A-4147-A177-3AD203B41FA5}">
                      <a16:colId xmlns:a16="http://schemas.microsoft.com/office/drawing/2014/main" val="1221182312"/>
                    </a:ext>
                  </a:extLst>
                </a:gridCol>
                <a:gridCol w="2199059">
                  <a:extLst>
                    <a:ext uri="{9D8B030D-6E8A-4147-A177-3AD203B41FA5}">
                      <a16:colId xmlns:a16="http://schemas.microsoft.com/office/drawing/2014/main" val="3978640479"/>
                    </a:ext>
                  </a:extLst>
                </a:gridCol>
                <a:gridCol w="2540044">
                  <a:extLst>
                    <a:ext uri="{9D8B030D-6E8A-4147-A177-3AD203B41FA5}">
                      <a16:colId xmlns:a16="http://schemas.microsoft.com/office/drawing/2014/main" val="1385667000"/>
                    </a:ext>
                  </a:extLst>
                </a:gridCol>
                <a:gridCol w="944217">
                  <a:extLst>
                    <a:ext uri="{9D8B030D-6E8A-4147-A177-3AD203B41FA5}">
                      <a16:colId xmlns:a16="http://schemas.microsoft.com/office/drawing/2014/main" val="165975565"/>
                    </a:ext>
                  </a:extLst>
                </a:gridCol>
                <a:gridCol w="1027044">
                  <a:extLst>
                    <a:ext uri="{9D8B030D-6E8A-4147-A177-3AD203B41FA5}">
                      <a16:colId xmlns:a16="http://schemas.microsoft.com/office/drawing/2014/main" val="3320470543"/>
                    </a:ext>
                  </a:extLst>
                </a:gridCol>
              </a:tblGrid>
              <a:tr h="172564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b="1" u="none" strike="noStrike" dirty="0" err="1">
                          <a:effectLst/>
                        </a:rPr>
                        <a:t>Designed</a:t>
                      </a:r>
                      <a:r>
                        <a:rPr lang="sv-SE" sz="1000" b="1" u="none" strike="noStrike" dirty="0">
                          <a:effectLst/>
                        </a:rPr>
                        <a:t> </a:t>
                      </a:r>
                      <a:r>
                        <a:rPr lang="sv-SE" sz="1000" b="1" u="none" strike="noStrike" dirty="0" err="1">
                          <a:effectLst/>
                        </a:rPr>
                        <a:t>sequences</a:t>
                      </a:r>
                      <a:r>
                        <a:rPr lang="sv-SE" sz="1000" b="1" u="none" strike="noStrike" dirty="0">
                          <a:effectLst/>
                        </a:rPr>
                        <a:t> for CRISPR </a:t>
                      </a:r>
                      <a:r>
                        <a:rPr lang="sv-SE" sz="1000" b="1" u="none" strike="noStrike" dirty="0" err="1">
                          <a:effectLst/>
                        </a:rPr>
                        <a:t>pegRNA</a:t>
                      </a:r>
                      <a:r>
                        <a:rPr lang="sv-SE" sz="1000" b="1" u="none" strike="noStrike" dirty="0">
                          <a:effectLst/>
                        </a:rPr>
                        <a:t> and </a:t>
                      </a:r>
                      <a:r>
                        <a:rPr lang="sv-SE" sz="1000" b="1" u="none" strike="noStrike" dirty="0" err="1">
                          <a:effectLst/>
                        </a:rPr>
                        <a:t>ngRNA</a:t>
                      </a:r>
                      <a:r>
                        <a:rPr lang="sv-SE" sz="1000" b="1" u="none" strike="noStrike" dirty="0">
                          <a:effectLst/>
                        </a:rPr>
                        <a:t> </a:t>
                      </a:r>
                      <a:endParaRPr lang="sv-SE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extLst>
                  <a:ext uri="{0D108BD9-81ED-4DB2-BD59-A6C34878D82A}">
                    <a16:rowId xmlns:a16="http://schemas.microsoft.com/office/drawing/2014/main" val="2308951871"/>
                  </a:ext>
                </a:extLst>
              </a:tr>
              <a:tr h="292819"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spacer sequence (5′ to 3′)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3' extension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PBS length (nt)</a:t>
                      </a:r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sng" strike="noStrike" dirty="0">
                          <a:effectLst/>
                        </a:rPr>
                        <a:t>RTT </a:t>
                      </a:r>
                      <a:r>
                        <a:rPr lang="sv-SE" sz="900" u="sng" strike="noStrike" dirty="0" err="1">
                          <a:effectLst/>
                        </a:rPr>
                        <a:t>length</a:t>
                      </a:r>
                      <a:r>
                        <a:rPr lang="sv-SE" sz="900" u="sng" strike="noStrike" dirty="0">
                          <a:effectLst/>
                        </a:rPr>
                        <a:t> (nt)</a:t>
                      </a:r>
                      <a:endParaRPr lang="sv-SE" sz="900" b="0" i="0" u="sng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extLst>
                  <a:ext uri="{0D108BD9-81ED-4DB2-BD59-A6C34878D82A}">
                    <a16:rowId xmlns:a16="http://schemas.microsoft.com/office/drawing/2014/main" val="2346015381"/>
                  </a:ext>
                </a:extLst>
              </a:tr>
              <a:tr h="161778"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pegRNA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TTCTGGAGTCCTTATTCACT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GGCAGGGTATaAAACC</a:t>
                      </a:r>
                      <a:r>
                        <a:rPr lang="sv-SE" sz="900" u="sng" strike="noStrike">
                          <a:effectLst/>
                        </a:rPr>
                        <a:t>CAGTGAATAAGGACTCCAGA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16</a:t>
                      </a:r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sng" strike="noStrike">
                          <a:effectLst/>
                        </a:rPr>
                        <a:t>20</a:t>
                      </a:r>
                      <a:endParaRPr lang="sv-SE" sz="900" b="0" i="0" u="sng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extLst>
                  <a:ext uri="{0D108BD9-81ED-4DB2-BD59-A6C34878D82A}">
                    <a16:rowId xmlns:a16="http://schemas.microsoft.com/office/drawing/2014/main" val="3320919193"/>
                  </a:ext>
                </a:extLst>
              </a:tr>
              <a:tr h="161778"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nicking sgRNA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GGTATaAAACCCAGTGAATA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extLst>
                  <a:ext uri="{0D108BD9-81ED-4DB2-BD59-A6C34878D82A}">
                    <a16:rowId xmlns:a16="http://schemas.microsoft.com/office/drawing/2014/main" val="2080974128"/>
                  </a:ext>
                </a:extLst>
              </a:tr>
              <a:tr h="161778">
                <a:tc gridSpan="2"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*PBS: primer binding sequence; RTT: reverse transcription template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89" marR="8089" marT="8089" marB="0" anchor="b"/>
                </a:tc>
                <a:extLst>
                  <a:ext uri="{0D108BD9-81ED-4DB2-BD59-A6C34878D82A}">
                    <a16:rowId xmlns:a16="http://schemas.microsoft.com/office/drawing/2014/main" val="135090409"/>
                  </a:ext>
                </a:extLst>
              </a:tr>
            </a:tbl>
          </a:graphicData>
        </a:graphic>
      </p:graphicFrame>
      <p:graphicFrame>
        <p:nvGraphicFramePr>
          <p:cNvPr id="6" name="Tabell 5">
            <a:extLst>
              <a:ext uri="{FF2B5EF4-FFF2-40B4-BE49-F238E27FC236}">
                <a16:creationId xmlns:a16="http://schemas.microsoft.com/office/drawing/2014/main" id="{DFC70FB1-9D2D-E004-4ECE-A5963CF82F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80601869"/>
              </p:ext>
            </p:extLst>
          </p:nvPr>
        </p:nvGraphicFramePr>
        <p:xfrm>
          <a:off x="649357" y="2489363"/>
          <a:ext cx="10515600" cy="172096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657050">
                  <a:extLst>
                    <a:ext uri="{9D8B030D-6E8A-4147-A177-3AD203B41FA5}">
                      <a16:colId xmlns:a16="http://schemas.microsoft.com/office/drawing/2014/main" val="3791027775"/>
                    </a:ext>
                  </a:extLst>
                </a:gridCol>
                <a:gridCol w="809866">
                  <a:extLst>
                    <a:ext uri="{9D8B030D-6E8A-4147-A177-3AD203B41FA5}">
                      <a16:colId xmlns:a16="http://schemas.microsoft.com/office/drawing/2014/main" val="693510145"/>
                    </a:ext>
                  </a:extLst>
                </a:gridCol>
                <a:gridCol w="6048684">
                  <a:extLst>
                    <a:ext uri="{9D8B030D-6E8A-4147-A177-3AD203B41FA5}">
                      <a16:colId xmlns:a16="http://schemas.microsoft.com/office/drawing/2014/main" val="2315080844"/>
                    </a:ext>
                  </a:extLst>
                </a:gridCol>
              </a:tblGrid>
              <a:tr h="202466"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b="1" u="none" strike="noStrike" dirty="0" err="1">
                          <a:effectLst/>
                        </a:rPr>
                        <a:t>synthezied</a:t>
                      </a:r>
                      <a:r>
                        <a:rPr lang="sv-SE" sz="1200" b="1" u="none" strike="noStrike" dirty="0">
                          <a:effectLst/>
                        </a:rPr>
                        <a:t> </a:t>
                      </a:r>
                      <a:r>
                        <a:rPr lang="sv-SE" sz="1200" b="1" u="none" strike="noStrike" dirty="0" err="1">
                          <a:effectLst/>
                        </a:rPr>
                        <a:t>oligos</a:t>
                      </a:r>
                      <a:endParaRPr lang="sv-SE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extLst>
                  <a:ext uri="{0D108BD9-81ED-4DB2-BD59-A6C34878D82A}">
                    <a16:rowId xmlns:a16="http://schemas.microsoft.com/office/drawing/2014/main" val="198045890"/>
                  </a:ext>
                </a:extLst>
              </a:tr>
              <a:tr h="1898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pegRNA spacer annealed oligos 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Forward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5′- caccGTTCTGGAGTCCTTATTCACTgtttt -3′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extLst>
                  <a:ext uri="{0D108BD9-81ED-4DB2-BD59-A6C34878D82A}">
                    <a16:rowId xmlns:a16="http://schemas.microsoft.com/office/drawing/2014/main" val="2020327302"/>
                  </a:ext>
                </a:extLst>
              </a:tr>
              <a:tr h="189812">
                <a:tc>
                  <a:txBody>
                    <a:bodyPr/>
                    <a:lstStyle/>
                    <a:p>
                      <a:pPr algn="l" fontAlgn="b"/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Reverse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5′- ctctaaaacAGTGAATAAGGACTCCAGAAC -3′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extLst>
                  <a:ext uri="{0D108BD9-81ED-4DB2-BD59-A6C34878D82A}">
                    <a16:rowId xmlns:a16="http://schemas.microsoft.com/office/drawing/2014/main" val="587587476"/>
                  </a:ext>
                </a:extLst>
              </a:tr>
              <a:tr h="1898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pegRNA 3′ extension annealed oligos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Forward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5′- gtgcGGCAGGGTATaAAACCCAGTGAATAAGGACTCCAGA -3′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extLst>
                  <a:ext uri="{0D108BD9-81ED-4DB2-BD59-A6C34878D82A}">
                    <a16:rowId xmlns:a16="http://schemas.microsoft.com/office/drawing/2014/main" val="3946324030"/>
                  </a:ext>
                </a:extLst>
              </a:tr>
              <a:tr h="189812">
                <a:tc>
                  <a:txBody>
                    <a:bodyPr/>
                    <a:lstStyle/>
                    <a:p>
                      <a:pPr algn="l" fontAlgn="b"/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Reverse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5′-  aaaaTCTGGAGTCCTTATTCACTGGGTTTtATACCCTGCC -3'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extLst>
                  <a:ext uri="{0D108BD9-81ED-4DB2-BD59-A6C34878D82A}">
                    <a16:rowId xmlns:a16="http://schemas.microsoft.com/office/drawing/2014/main" val="1712703072"/>
                  </a:ext>
                </a:extLst>
              </a:tr>
              <a:tr h="1898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nicking sgRNA spacer annealed oligos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Forward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5′- caccGGTATaAAACCCAGTGAATA -3′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extLst>
                  <a:ext uri="{0D108BD9-81ED-4DB2-BD59-A6C34878D82A}">
                    <a16:rowId xmlns:a16="http://schemas.microsoft.com/office/drawing/2014/main" val="1100924373"/>
                  </a:ext>
                </a:extLst>
              </a:tr>
              <a:tr h="189812">
                <a:tc>
                  <a:txBody>
                    <a:bodyPr/>
                    <a:lstStyle/>
                    <a:p>
                      <a:pPr algn="l" fontAlgn="b"/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Reverse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5′-  aaacTATTCACTGGGTTTtATACC -3'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extLst>
                  <a:ext uri="{0D108BD9-81ED-4DB2-BD59-A6C34878D82A}">
                    <a16:rowId xmlns:a16="http://schemas.microsoft.com/office/drawing/2014/main" val="2281348525"/>
                  </a:ext>
                </a:extLst>
              </a:tr>
              <a:tr h="1898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pegRNA scaffold annealed oligos (5' phosphorylated)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Forward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5' (Phos</a:t>
                      </a:r>
                      <a:r>
                        <a:rPr lang="sv-SE" sz="900" u="none" strike="noStrike">
                          <a:effectLst/>
                        </a:rPr>
                        <a:t>)-agagCTAGAAATAGCAAGTTAAAATAAGGCTAGTCCGTTATCAACTTGAAAAAGTGGCACCGAGTCG - 3' 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extLst>
                  <a:ext uri="{0D108BD9-81ED-4DB2-BD59-A6C34878D82A}">
                    <a16:rowId xmlns:a16="http://schemas.microsoft.com/office/drawing/2014/main" val="155221796"/>
                  </a:ext>
                </a:extLst>
              </a:tr>
              <a:tr h="189812">
                <a:tc>
                  <a:txBody>
                    <a:bodyPr/>
                    <a:lstStyle/>
                    <a:p>
                      <a:pPr algn="l" fontAlgn="b"/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Reverse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 dirty="0">
                          <a:effectLst/>
                        </a:rPr>
                        <a:t>5' (</a:t>
                      </a:r>
                      <a:r>
                        <a:rPr lang="sv-SE" sz="1100" u="none" strike="noStrike" dirty="0" err="1">
                          <a:effectLst/>
                        </a:rPr>
                        <a:t>Phos</a:t>
                      </a:r>
                      <a:r>
                        <a:rPr lang="sv-SE" sz="900" u="none" strike="noStrike" dirty="0">
                          <a:effectLst/>
                        </a:rPr>
                        <a:t>)-gcacCGACTCGGTGCCACTTTTTCAAGTTGATAACGGACTAGCCTTATTTTAACTTGCTATTTCTAG- 3'</a:t>
                      </a:r>
                      <a:endParaRPr lang="sv-S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91" marR="9491" marT="9491" marB="0" anchor="b"/>
                </a:tc>
                <a:extLst>
                  <a:ext uri="{0D108BD9-81ED-4DB2-BD59-A6C34878D82A}">
                    <a16:rowId xmlns:a16="http://schemas.microsoft.com/office/drawing/2014/main" val="385463026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170463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17DF1EC9-96F9-8007-244C-9F7C9F85EF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0452" y="5532437"/>
            <a:ext cx="10233991" cy="697189"/>
          </a:xfrm>
        </p:spPr>
        <p:txBody>
          <a:bodyPr/>
          <a:lstStyle/>
          <a:p>
            <a:r>
              <a:rPr lang="sv-SE" sz="1400" b="1" dirty="0"/>
              <a:t>Suppl. Table 5</a:t>
            </a:r>
            <a:br>
              <a:rPr lang="sv-SE" dirty="0"/>
            </a:br>
            <a:r>
              <a:rPr lang="sv-SE" sz="1200" dirty="0"/>
              <a:t>Primers </a:t>
            </a:r>
            <a:r>
              <a:rPr lang="sv-SE" sz="1200" dirty="0" err="1"/>
              <a:t>used</a:t>
            </a:r>
            <a:r>
              <a:rPr lang="sv-SE" sz="1200" dirty="0"/>
              <a:t> for </a:t>
            </a:r>
            <a:r>
              <a:rPr lang="sv-SE" sz="1200" dirty="0" err="1"/>
              <a:t>qPCR</a:t>
            </a:r>
            <a:endParaRPr lang="sv-SE" sz="1200" dirty="0"/>
          </a:p>
        </p:txBody>
      </p:sp>
      <p:graphicFrame>
        <p:nvGraphicFramePr>
          <p:cNvPr id="3" name="Tabell 2">
            <a:extLst>
              <a:ext uri="{FF2B5EF4-FFF2-40B4-BE49-F238E27FC236}">
                <a16:creationId xmlns:a16="http://schemas.microsoft.com/office/drawing/2014/main" id="{84E61B2A-E75C-86E7-0D32-94F806FC7BF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38793870"/>
              </p:ext>
            </p:extLst>
          </p:nvPr>
        </p:nvGraphicFramePr>
        <p:xfrm>
          <a:off x="1154595" y="628374"/>
          <a:ext cx="7880074" cy="456420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53732">
                  <a:extLst>
                    <a:ext uri="{9D8B030D-6E8A-4147-A177-3AD203B41FA5}">
                      <a16:colId xmlns:a16="http://schemas.microsoft.com/office/drawing/2014/main" val="2255748172"/>
                    </a:ext>
                  </a:extLst>
                </a:gridCol>
                <a:gridCol w="3362952">
                  <a:extLst>
                    <a:ext uri="{9D8B030D-6E8A-4147-A177-3AD203B41FA5}">
                      <a16:colId xmlns:a16="http://schemas.microsoft.com/office/drawing/2014/main" val="397247353"/>
                    </a:ext>
                  </a:extLst>
                </a:gridCol>
                <a:gridCol w="3263390">
                  <a:extLst>
                    <a:ext uri="{9D8B030D-6E8A-4147-A177-3AD203B41FA5}">
                      <a16:colId xmlns:a16="http://schemas.microsoft.com/office/drawing/2014/main" val="3641717412"/>
                    </a:ext>
                  </a:extLst>
                </a:gridCol>
              </a:tblGrid>
              <a:tr h="272707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 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b="1" u="none" strike="noStrike" dirty="0">
                          <a:effectLst/>
                        </a:rPr>
                        <a:t>Forward (5'-3')</a:t>
                      </a:r>
                      <a:endParaRPr lang="sv-S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b="1" u="none" strike="noStrike" dirty="0" err="1">
                          <a:effectLst/>
                        </a:rPr>
                        <a:t>Reverse</a:t>
                      </a:r>
                      <a:r>
                        <a:rPr lang="sv-SE" sz="1100" b="1" u="none" strike="noStrike" dirty="0">
                          <a:effectLst/>
                        </a:rPr>
                        <a:t> (5'-3')</a:t>
                      </a:r>
                      <a:endParaRPr lang="sv-S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32653706"/>
                  </a:ext>
                </a:extLst>
              </a:tr>
              <a:tr h="272707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Insulin</a:t>
                      </a:r>
                      <a:endParaRPr lang="sv-SE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 dirty="0">
                          <a:effectLst/>
                        </a:rPr>
                        <a:t>GCA GCC TTT GTG AAC CAA CAC</a:t>
                      </a:r>
                      <a:endParaRPr lang="sv-S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CCC CGC ACA CTA GGT AGA GA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21276058"/>
                  </a:ext>
                </a:extLst>
              </a:tr>
              <a:tr h="272707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Glucagon</a:t>
                      </a:r>
                      <a:endParaRPr lang="sv-SE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CTG AAG GGA CCT TTA CCA GTG A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CCT GGC GGC AAG ATT ATC AAG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08924847"/>
                  </a:ext>
                </a:extLst>
              </a:tr>
              <a:tr h="281797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Pax4</a:t>
                      </a:r>
                      <a:endParaRPr lang="sv-SE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ATA CCC GGC AGC AGA TTG TG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AAG ACA CCT GTG CGG TAG TAA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11738957"/>
                  </a:ext>
                </a:extLst>
              </a:tr>
              <a:tr h="493599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Arx</a:t>
                      </a:r>
                      <a:endParaRPr lang="sv-SE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CTT CCT CCT GAC ACC CCA C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br>
                        <a:rPr lang="sv-SE" sz="1100" u="none" strike="noStrike">
                          <a:effectLst/>
                        </a:rPr>
                      </a:br>
                      <a:r>
                        <a:rPr lang="sv-SE" sz="1100" u="none" strike="noStrike">
                          <a:effectLst/>
                        </a:rPr>
                        <a:t>CAA GAA CAA GAC GCC CCT TTC C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85201711"/>
                  </a:ext>
                </a:extLst>
              </a:tr>
              <a:tr h="272707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IAPP</a:t>
                      </a:r>
                      <a:endParaRPr lang="sv-SE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sv-SE" sz="1100" u="none" strike="noStrike">
                          <a:effectLst/>
                        </a:rPr>
                        <a:t>AGC GGA AAT GCA ACA CTG CCA C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 dirty="0">
                          <a:effectLst/>
                        </a:rPr>
                        <a:t>CGT TGG TAG ATG AGA GAA TGG CA</a:t>
                      </a:r>
                      <a:endParaRPr lang="sv-S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78951374"/>
                  </a:ext>
                </a:extLst>
              </a:tr>
              <a:tr h="272707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 dirty="0" err="1">
                          <a:effectLst/>
                        </a:rPr>
                        <a:t>Myc</a:t>
                      </a:r>
                      <a:endParaRPr lang="sv-S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GGC TCC TGG CAA AAG GTC A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CTG CGT AGT TGT GCT GAT GT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28485291"/>
                  </a:ext>
                </a:extLst>
              </a:tr>
              <a:tr h="263616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FoxB1</a:t>
                      </a:r>
                      <a:endParaRPr lang="sv-SE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ACA TCT CGC TGA CCG CTA TG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GCT GCG TGT TCT CCC TGT AG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58780450"/>
                  </a:ext>
                </a:extLst>
              </a:tr>
              <a:tr h="272707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GLP1R</a:t>
                      </a:r>
                      <a:endParaRPr lang="sv-SE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GGT GCA GAA ATG GCG AGA ATA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CCG GTT GCA GAA CAA GTC TGT 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80805431"/>
                  </a:ext>
                </a:extLst>
              </a:tr>
              <a:tr h="30452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SERPINA1</a:t>
                      </a:r>
                      <a:endParaRPr lang="sv-SE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ATG CTG CCC AGA AGA CAG ATA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CTG AAG GCG AAC TCA GCC A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75076167"/>
                  </a:ext>
                </a:extLst>
              </a:tr>
              <a:tr h="272707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HK1</a:t>
                      </a:r>
                      <a:endParaRPr lang="sv-SE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GCT CTC CGA TGA AAC TCT CAT AG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GGA CCT TAC GAA TGT TGG CAA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74553921"/>
                  </a:ext>
                </a:extLst>
              </a:tr>
              <a:tr h="493599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PDGFRB</a:t>
                      </a:r>
                      <a:endParaRPr lang="sv-SE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AGC ACC TTC GTT CTG ACC TG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br>
                        <a:rPr lang="sv-SE" sz="1100" u="none" strike="noStrike">
                          <a:effectLst/>
                        </a:rPr>
                      </a:br>
                      <a:r>
                        <a:rPr lang="sv-SE" sz="1100" u="none" strike="noStrike">
                          <a:effectLst/>
                        </a:rPr>
                        <a:t>TAT TCT CCC GTG TCT AGC CCA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2059427"/>
                  </a:ext>
                </a:extLst>
              </a:tr>
              <a:tr h="272707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NEUROG3</a:t>
                      </a:r>
                      <a:endParaRPr lang="sv-SE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 dirty="0">
                          <a:effectLst/>
                        </a:rPr>
                        <a:t>CTA AGA GCG AGT TGG CAC TGA</a:t>
                      </a:r>
                      <a:endParaRPr lang="sv-S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GAG GTT GTG CAT TCG ATT GCG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8313760"/>
                  </a:ext>
                </a:extLst>
              </a:tr>
              <a:tr h="272707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 dirty="0">
                          <a:effectLst/>
                        </a:rPr>
                        <a:t>LDH</a:t>
                      </a:r>
                      <a:r>
                        <a:rPr lang="sv-SE" sz="11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 dirty="0">
                          <a:effectLst/>
                        </a:rPr>
                        <a:t>ATG GCA ACT CTA AAG GAT CAG C</a:t>
                      </a:r>
                      <a:endParaRPr lang="sv-S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 dirty="0">
                          <a:effectLst/>
                        </a:rPr>
                        <a:t>CCA ACC CCA ACA ACT GTA ATC T</a:t>
                      </a:r>
                      <a:endParaRPr lang="sv-S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21387648"/>
                  </a:ext>
                </a:extLst>
              </a:tr>
              <a:tr h="272707"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en-US" altLang="zh-CN" sz="11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eta-actin</a:t>
                      </a:r>
                      <a:endParaRPr lang="sv-SE" sz="1100" u="none" strike="noStrike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1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AT GTA CGT TGC TAT CCA GGC</a:t>
                      </a:r>
                    </a:p>
                  </a:txBody>
                  <a:tcPr marL="15240" marR="15240" marT="15240" marB="1524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1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TC CTT AAT GTC ACG CAC GAT</a:t>
                      </a:r>
                    </a:p>
                  </a:txBody>
                  <a:tcPr marL="15240" marR="15240" marT="15240" marB="15240" anchor="ctr"/>
                </a:tc>
                <a:extLst>
                  <a:ext uri="{0D108BD9-81ED-4DB2-BD59-A6C34878D82A}">
                    <a16:rowId xmlns:a16="http://schemas.microsoft.com/office/drawing/2014/main" val="151140718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17126824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0bf009cb-3db5-4806-9953-d162ca61fc4b"/>
  <p:tag name="COMMONDATA" val="eyJoZGlkIjoiYWJmNTAxYTA0NTllZTU0OWY5NWY0MWNlMzBjNGU2OTYifQ=="/>
</p:tagLst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87</TotalTime>
  <Words>751</Words>
  <Application>Microsoft Macintosh PowerPoint</Application>
  <PresentationFormat>Bredbild</PresentationFormat>
  <Paragraphs>166</Paragraphs>
  <Slides>5</Slides>
  <Notes>0</Notes>
  <HiddenSlides>0</HiddenSlides>
  <MMClips>0</MMClips>
  <ScaleCrop>false</ScaleCrop>
  <HeadingPairs>
    <vt:vector size="8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Serverprogram för OLE-inbäddning</vt:lpstr>
      </vt:variant>
      <vt:variant>
        <vt:i4>1</vt:i4>
      </vt:variant>
      <vt:variant>
        <vt:lpstr>Bildrubriker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-tema</vt:lpstr>
      <vt:lpstr>Kalkylblad</vt:lpstr>
      <vt:lpstr>Suppl. Table 1 List of DE genes (see separate File).</vt:lpstr>
      <vt:lpstr>PowerPoint-presentation</vt:lpstr>
      <vt:lpstr>Suppl. Table 3 Alternatively spliced genes when comparing wt 1-5 with mut 1-3 clones. RI=retained introns, MXE=mutually exclusive exons, A5SS=alternative 5’ splice site, A3SS=alternative 3’ splice site, SE=exon skipping</vt:lpstr>
      <vt:lpstr>Suppl. Table 4 Primers used for prime editing</vt:lpstr>
      <vt:lpstr>Suppl. Table 5 Primers used for qPCR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Nils Welsh</dc:creator>
  <cp:lastModifiedBy>Nils Welsh</cp:lastModifiedBy>
  <cp:revision>50</cp:revision>
  <cp:lastPrinted>2023-06-01T14:08:39Z</cp:lastPrinted>
  <dcterms:created xsi:type="dcterms:W3CDTF">2022-08-24T10:29:00Z</dcterms:created>
  <dcterms:modified xsi:type="dcterms:W3CDTF">2025-11-24T10:05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821BDDB29D684F2A8E50684531048FB0</vt:lpwstr>
  </property>
  <property fmtid="{D5CDD505-2E9C-101B-9397-08002B2CF9AE}" pid="3" name="KSOProductBuildVer">
    <vt:lpwstr>2052-11.1.0.14036</vt:lpwstr>
  </property>
</Properties>
</file>